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0" autoAdjust="0"/>
    <p:restoredTop sz="94660"/>
  </p:normalViewPr>
  <p:slideViewPr>
    <p:cSldViewPr snapToGrid="0">
      <p:cViewPr varScale="1">
        <p:scale>
          <a:sx n="73" d="100"/>
          <a:sy n="73" d="100"/>
        </p:scale>
        <p:origin x="2592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631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4454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4618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561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155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76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852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4528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74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768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8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1F3AB-0395-42A2-A544-A1729FA810A1}" type="datetimeFigureOut">
              <a:rPr lang="en-GB" smtClean="0"/>
              <a:t>26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9F37A-3F62-4D53-AF1C-C277E90535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339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8640" y="431074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254" y="1284072"/>
            <a:ext cx="6636258" cy="561776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85643" y="7440460"/>
            <a:ext cx="559913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etwork analysis showing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mRNA interactions for the 16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iR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upregulated in low folate status placenta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rect interactions are denoted by solid lines and predicted by dashed lines. Upregulat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R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re shown in red and 4 key genes known to be important in placental function and fetal growth, CDK6, MYC, PTEN and insulin are highlight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641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</TotalTime>
  <Words>67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mily Baker</dc:creator>
  <cp:lastModifiedBy>Family Baker</cp:lastModifiedBy>
  <cp:revision>7</cp:revision>
  <dcterms:created xsi:type="dcterms:W3CDTF">2016-11-15T21:52:32Z</dcterms:created>
  <dcterms:modified xsi:type="dcterms:W3CDTF">2016-11-26T16:55:57Z</dcterms:modified>
</cp:coreProperties>
</file>